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308" r:id="rId2"/>
    <p:sldId id="309" r:id="rId3"/>
  </p:sldIdLst>
  <p:sldSz cx="6858000" cy="9906000" type="A4"/>
  <p:notesSz cx="6669088" cy="9926638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44" roundtripDataSignature="AMtx7midPRuFTzd7175hgEXLH8/FnCpbMg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2A6B768-FD5F-7E08-29BA-645110A844E6}" name="Wong, Stephen Q." initials="SW" userId="S::swong@houstonmethodist.org::2a8ec965-c961-44eb-8898-f2952af7cd62" providerId="AD"/>
  <p188:author id="{FBBDEF89-E001-42E6-A122-65C359D21E47}" name="dasmohua1991@gmail.com" initials="d" userId="c47b03fee764e2f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A4FF6B"/>
    <a:srgbClr val="0432FF"/>
    <a:srgbClr val="A67728"/>
    <a:srgbClr val="00C700"/>
    <a:srgbClr val="521B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F0DF16DD-CEAE-429F-B386-2EFEC26C250D}">
  <a:tblStyle styleId="{F0DF16DD-CEAE-429F-B386-2EFEC26C250D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chemeClr val="lt1"/>
          </a:solidFill>
        </a:fill>
      </a:tcStyle>
    </a:wholeTbl>
    <a:band1H>
      <a:tcTxStyle b="off" i="off"/>
      <a:tcStyle>
        <a:tcBdr/>
        <a:fill>
          <a:solidFill>
            <a:srgbClr val="E6E6E6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E6E6E6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/>
      <a:tcStyle>
        <a:tcBdr>
          <a:top>
            <a:ln w="508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lt1"/>
          </a:solidFill>
        </a:fill>
      </a:tcStyle>
    </a:lastRow>
    <a:se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eCell>
    <a:sw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13351516-2F73-430D-880C-78F66EE1126C}" styleName="Table_1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6E6E6"/>
          </a:solidFill>
        </a:fill>
      </a:tcStyle>
    </a:wholeTbl>
    <a:band1H>
      <a:tcTxStyle b="off" i="off"/>
      <a:tcStyle>
        <a:tcBdr/>
        <a:fill>
          <a:solidFill>
            <a:srgbClr val="CACAC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ACAC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dk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013"/>
    <p:restoredTop sz="94855"/>
  </p:normalViewPr>
  <p:slideViewPr>
    <p:cSldViewPr snapToGrid="0">
      <p:cViewPr varScale="1">
        <p:scale>
          <a:sx n="78" d="100"/>
          <a:sy n="78" d="100"/>
        </p:scale>
        <p:origin x="2816" y="192"/>
      </p:cViewPr>
      <p:guideLst>
        <p:guide orient="horz" pos="3143"/>
        <p:guide pos="2160"/>
      </p:guideLst>
    </p:cSldViewPr>
  </p:slideViewPr>
  <p:notesTextViewPr>
    <p:cViewPr>
      <p:scale>
        <a:sx n="170" d="100"/>
        <a:sy n="17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7" Type="http://schemas.openxmlformats.org/officeDocument/2006/relationships/theme" Target="theme/theme1.xml"/><Relationship Id="rId46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45" Type="http://schemas.openxmlformats.org/officeDocument/2006/relationships/presProps" Target="presProps.xml"/><Relationship Id="rId49" Type="http://schemas.microsoft.com/office/2018/10/relationships/authors" Target="authors.xml"/><Relationship Id="rId44" Type="http://customschemas.google.com/relationships/presentationmetadata" Target="metadata"/><Relationship Id="rId4" Type="http://schemas.openxmlformats.org/officeDocument/2006/relationships/notesMaster" Target="notesMasters/notesMaster1.xml"/><Relationship Id="rId48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777607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176463" y="1241425"/>
            <a:ext cx="2316162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66909" y="4777194"/>
            <a:ext cx="533527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946230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2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2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2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2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5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25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2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6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6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6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7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8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8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7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graph&#10;&#10;Description automatically generated">
            <a:extLst>
              <a:ext uri="{FF2B5EF4-FFF2-40B4-BE49-F238E27FC236}">
                <a16:creationId xmlns:a16="http://schemas.microsoft.com/office/drawing/2014/main" id="{888CDF37-0037-04CF-4E0A-1A568296646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280" t="1317" b="7447"/>
          <a:stretch/>
        </p:blipFill>
        <p:spPr>
          <a:xfrm>
            <a:off x="646513" y="4403789"/>
            <a:ext cx="5532081" cy="2675823"/>
          </a:xfrm>
          <a:prstGeom prst="rect">
            <a:avLst/>
          </a:prstGeom>
          <a:ln>
            <a:noFill/>
          </a:ln>
        </p:spPr>
      </p:pic>
      <p:pic>
        <p:nvPicPr>
          <p:cNvPr id="5" name="Picture 4" descr="A white screen with blue and red lines&#10;&#10;Description automatically generated">
            <a:extLst>
              <a:ext uri="{FF2B5EF4-FFF2-40B4-BE49-F238E27FC236}">
                <a16:creationId xmlns:a16="http://schemas.microsoft.com/office/drawing/2014/main" id="{7875F2A3-AC60-1C41-C286-CCCF58526A8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826" t="1453"/>
          <a:stretch/>
        </p:blipFill>
        <p:spPr>
          <a:xfrm>
            <a:off x="679405" y="916442"/>
            <a:ext cx="5499189" cy="2890211"/>
          </a:xfrm>
          <a:prstGeom prst="rect">
            <a:avLst/>
          </a:prstGeom>
          <a:ln>
            <a:noFill/>
          </a:ln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E2364E1A-3251-13B1-BAF8-B61DD5D4D1E2}"/>
              </a:ext>
            </a:extLst>
          </p:cNvPr>
          <p:cNvCxnSpPr>
            <a:cxnSpLocks/>
            <a:endCxn id="21" idx="1"/>
          </p:cNvCxnSpPr>
          <p:nvPr/>
        </p:nvCxnSpPr>
        <p:spPr>
          <a:xfrm flipH="1">
            <a:off x="607531" y="3806653"/>
            <a:ext cx="629787" cy="540492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sysDot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CEB1188-A386-4060-A1D7-0E10AA24E1BD}"/>
              </a:ext>
            </a:extLst>
          </p:cNvPr>
          <p:cNvCxnSpPr>
            <a:cxnSpLocks/>
          </p:cNvCxnSpPr>
          <p:nvPr/>
        </p:nvCxnSpPr>
        <p:spPr>
          <a:xfrm>
            <a:off x="1237318" y="3806653"/>
            <a:ext cx="4858682" cy="597136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sysDot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pic>
        <p:nvPicPr>
          <p:cNvPr id="23" name="Picture 22">
            <a:extLst>
              <a:ext uri="{FF2B5EF4-FFF2-40B4-BE49-F238E27FC236}">
                <a16:creationId xmlns:a16="http://schemas.microsoft.com/office/drawing/2014/main" id="{9B8718EB-7DFB-BF5C-0F7B-BC5B21187FA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4126" y="7349826"/>
            <a:ext cx="5530083" cy="493363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EBD69F23-A0FF-B4D7-9B61-21E080AE9E89}"/>
              </a:ext>
            </a:extLst>
          </p:cNvPr>
          <p:cNvSpPr txBox="1"/>
          <p:nvPr/>
        </p:nvSpPr>
        <p:spPr>
          <a:xfrm>
            <a:off x="2786303" y="7079612"/>
            <a:ext cx="10961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SMAD motif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03BAC45-42A3-0674-9389-4DF6C2EAB28B}"/>
              </a:ext>
            </a:extLst>
          </p:cNvPr>
          <p:cNvSpPr txBox="1"/>
          <p:nvPr/>
        </p:nvSpPr>
        <p:spPr>
          <a:xfrm>
            <a:off x="603783" y="751020"/>
            <a:ext cx="1624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hr7:101,125,104-101,141,247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D8A8D81-A973-9A6D-521D-A8C1387514F9}"/>
              </a:ext>
            </a:extLst>
          </p:cNvPr>
          <p:cNvSpPr/>
          <p:nvPr/>
        </p:nvSpPr>
        <p:spPr>
          <a:xfrm>
            <a:off x="3248155" y="3554868"/>
            <a:ext cx="302027" cy="743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/>
              <a:t>≈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54706E7-9E67-F386-C1C3-4E551DEEAD03}"/>
              </a:ext>
            </a:extLst>
          </p:cNvPr>
          <p:cNvSpPr/>
          <p:nvPr/>
        </p:nvSpPr>
        <p:spPr>
          <a:xfrm>
            <a:off x="3277132" y="3650606"/>
            <a:ext cx="302027" cy="743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/>
              <a:t>≈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A5AFAE-CA31-0371-9413-E33A8106466F}"/>
              </a:ext>
            </a:extLst>
          </p:cNvPr>
          <p:cNvSpPr txBox="1"/>
          <p:nvPr/>
        </p:nvSpPr>
        <p:spPr>
          <a:xfrm>
            <a:off x="3070547" y="3495183"/>
            <a:ext cx="56618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SERPINE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6AB743-6CBC-0ACC-99A3-A54D82353349}"/>
              </a:ext>
            </a:extLst>
          </p:cNvPr>
          <p:cNvSpPr txBox="1"/>
          <p:nvPr/>
        </p:nvSpPr>
        <p:spPr>
          <a:xfrm>
            <a:off x="3076897" y="3606308"/>
            <a:ext cx="56618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/>
              <a:t>SERPINE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E5A1A0C-BE60-BB2E-714D-806703F30EC0}"/>
              </a:ext>
            </a:extLst>
          </p:cNvPr>
          <p:cNvSpPr txBox="1"/>
          <p:nvPr/>
        </p:nvSpPr>
        <p:spPr>
          <a:xfrm>
            <a:off x="607531" y="4239423"/>
            <a:ext cx="1624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hr7:101,126,776-101,126,869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B2D52CE-0A6C-5EB5-4DEF-50E2023CE71A}"/>
              </a:ext>
            </a:extLst>
          </p:cNvPr>
          <p:cNvSpPr txBox="1"/>
          <p:nvPr/>
        </p:nvSpPr>
        <p:spPr>
          <a:xfrm>
            <a:off x="2323025" y="1303848"/>
            <a:ext cx="9541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432FF"/>
                </a:solidFill>
              </a:rPr>
              <a:t>HCT116-PAR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7E52BA8-55EC-C014-51C6-C11F19CB12F4}"/>
              </a:ext>
            </a:extLst>
          </p:cNvPr>
          <p:cNvSpPr txBox="1"/>
          <p:nvPr/>
        </p:nvSpPr>
        <p:spPr>
          <a:xfrm>
            <a:off x="2323025" y="1540536"/>
            <a:ext cx="9541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432FF"/>
                </a:solidFill>
              </a:rPr>
              <a:t>HCT116-PAR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4ECE749-537A-3221-2E3A-51416BAAA07C}"/>
              </a:ext>
            </a:extLst>
          </p:cNvPr>
          <p:cNvSpPr txBox="1"/>
          <p:nvPr/>
        </p:nvSpPr>
        <p:spPr>
          <a:xfrm>
            <a:off x="2323025" y="1806670"/>
            <a:ext cx="8643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C6C8FF"/>
                </a:solidFill>
              </a:rPr>
              <a:t>HCT116-LD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6BDFC9C-E98E-7837-0824-421A92F713EC}"/>
              </a:ext>
            </a:extLst>
          </p:cNvPr>
          <p:cNvSpPr txBox="1"/>
          <p:nvPr/>
        </p:nvSpPr>
        <p:spPr>
          <a:xfrm>
            <a:off x="2323025" y="2043358"/>
            <a:ext cx="8643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C6C8FF"/>
                </a:solidFill>
              </a:rPr>
              <a:t>HCT116-LD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E6C6CBF-7A32-31AD-0010-75EF481AEEE8}"/>
              </a:ext>
            </a:extLst>
          </p:cNvPr>
          <p:cNvSpPr txBox="1"/>
          <p:nvPr/>
        </p:nvSpPr>
        <p:spPr>
          <a:xfrm>
            <a:off x="2323025" y="2309492"/>
            <a:ext cx="8963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0FA00"/>
                </a:solidFill>
              </a:rPr>
              <a:t>HCT116-MD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0A4CA32-AD89-B79E-1371-BE891A2BE394}"/>
              </a:ext>
            </a:extLst>
          </p:cNvPr>
          <p:cNvSpPr txBox="1"/>
          <p:nvPr/>
        </p:nvSpPr>
        <p:spPr>
          <a:xfrm>
            <a:off x="2323025" y="2546180"/>
            <a:ext cx="8963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00FA00"/>
                </a:solidFill>
              </a:rPr>
              <a:t>HCT116-MD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68202AC-A0E7-73A3-587F-D0EA61F55ED4}"/>
              </a:ext>
            </a:extLst>
          </p:cNvPr>
          <p:cNvSpPr txBox="1"/>
          <p:nvPr/>
        </p:nvSpPr>
        <p:spPr>
          <a:xfrm>
            <a:off x="2323025" y="2812314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9300"/>
                </a:solidFill>
              </a:rPr>
              <a:t>HCT116-HD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741E80E-2AE4-50C3-A173-BE403430B85F}"/>
              </a:ext>
            </a:extLst>
          </p:cNvPr>
          <p:cNvSpPr txBox="1"/>
          <p:nvPr/>
        </p:nvSpPr>
        <p:spPr>
          <a:xfrm>
            <a:off x="2323025" y="3049002"/>
            <a:ext cx="8835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solidFill>
                  <a:srgbClr val="FF9300"/>
                </a:solidFill>
              </a:rPr>
              <a:t>HCT116-HD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570958D-2F07-D7E0-B14C-42419F3278D7}"/>
              </a:ext>
            </a:extLst>
          </p:cNvPr>
          <p:cNvSpPr txBox="1"/>
          <p:nvPr/>
        </p:nvSpPr>
        <p:spPr>
          <a:xfrm>
            <a:off x="1674510" y="4762269"/>
            <a:ext cx="8707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432FF"/>
                </a:solidFill>
              </a:rPr>
              <a:t>HCT116-PAR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651D05A-99E0-966C-823A-6A564517A626}"/>
              </a:ext>
            </a:extLst>
          </p:cNvPr>
          <p:cNvSpPr txBox="1"/>
          <p:nvPr/>
        </p:nvSpPr>
        <p:spPr>
          <a:xfrm>
            <a:off x="1674510" y="4998957"/>
            <a:ext cx="8707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432FF"/>
                </a:solidFill>
              </a:rPr>
              <a:t>HCT116-PAR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AB5F82D-20D6-8EE6-94A2-D0EBB921C767}"/>
              </a:ext>
            </a:extLst>
          </p:cNvPr>
          <p:cNvSpPr txBox="1"/>
          <p:nvPr/>
        </p:nvSpPr>
        <p:spPr>
          <a:xfrm>
            <a:off x="1674510" y="5265091"/>
            <a:ext cx="7906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C6C8FF"/>
                </a:solidFill>
              </a:rPr>
              <a:t>HCT116-LD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7170012-A37C-BB69-849D-0C5B61B6B506}"/>
              </a:ext>
            </a:extLst>
          </p:cNvPr>
          <p:cNvSpPr txBox="1"/>
          <p:nvPr/>
        </p:nvSpPr>
        <p:spPr>
          <a:xfrm>
            <a:off x="1674510" y="5501779"/>
            <a:ext cx="7906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C6C8FF"/>
                </a:solidFill>
              </a:rPr>
              <a:t>HCT116-LD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019093E-6B9E-3B66-0503-75ECC9F45898}"/>
              </a:ext>
            </a:extLst>
          </p:cNvPr>
          <p:cNvSpPr txBox="1"/>
          <p:nvPr/>
        </p:nvSpPr>
        <p:spPr>
          <a:xfrm>
            <a:off x="1674510" y="5767913"/>
            <a:ext cx="8178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0FA00"/>
                </a:solidFill>
              </a:rPr>
              <a:t>HCT116-MD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23F243A-4A8A-5E2B-8FC9-50F03DFE5EED}"/>
              </a:ext>
            </a:extLst>
          </p:cNvPr>
          <p:cNvSpPr txBox="1"/>
          <p:nvPr/>
        </p:nvSpPr>
        <p:spPr>
          <a:xfrm>
            <a:off x="1674510" y="6004601"/>
            <a:ext cx="8178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00FA00"/>
                </a:solidFill>
              </a:rPr>
              <a:t>HCT116-MD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D896CC4-193C-2E68-E52A-54263658BFDB}"/>
              </a:ext>
            </a:extLst>
          </p:cNvPr>
          <p:cNvSpPr txBox="1"/>
          <p:nvPr/>
        </p:nvSpPr>
        <p:spPr>
          <a:xfrm>
            <a:off x="1674510" y="6270735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9300"/>
                </a:solidFill>
              </a:rPr>
              <a:t>HCT116-HD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37620FC-D9CB-4AF5-4827-106E69E6F361}"/>
              </a:ext>
            </a:extLst>
          </p:cNvPr>
          <p:cNvSpPr txBox="1"/>
          <p:nvPr/>
        </p:nvSpPr>
        <p:spPr>
          <a:xfrm>
            <a:off x="1674510" y="6507423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solidFill>
                  <a:srgbClr val="FF9300"/>
                </a:solidFill>
              </a:rPr>
              <a:t>HCT116-HD2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31B93977-ED26-97B8-BD77-12FE7250AA08}"/>
              </a:ext>
            </a:extLst>
          </p:cNvPr>
          <p:cNvCxnSpPr>
            <a:cxnSpLocks/>
          </p:cNvCxnSpPr>
          <p:nvPr/>
        </p:nvCxnSpPr>
        <p:spPr>
          <a:xfrm>
            <a:off x="2959175" y="7102393"/>
            <a:ext cx="750452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641AA8D6-1888-6BC9-93C4-C3D36E572AAD}"/>
              </a:ext>
            </a:extLst>
          </p:cNvPr>
          <p:cNvCxnSpPr>
            <a:cxnSpLocks/>
          </p:cNvCxnSpPr>
          <p:nvPr/>
        </p:nvCxnSpPr>
        <p:spPr>
          <a:xfrm>
            <a:off x="1262257" y="1287222"/>
            <a:ext cx="0" cy="2487126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Google Shape;336;p9">
            <a:extLst>
              <a:ext uri="{FF2B5EF4-FFF2-40B4-BE49-F238E27FC236}">
                <a16:creationId xmlns:a16="http://schemas.microsoft.com/office/drawing/2014/main" id="{9E7CD78E-D757-C6D1-0D37-A9ADD1529A3C}"/>
              </a:ext>
            </a:extLst>
          </p:cNvPr>
          <p:cNvSpPr txBox="1"/>
          <p:nvPr/>
        </p:nvSpPr>
        <p:spPr>
          <a:xfrm>
            <a:off x="14630" y="597132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3" name="Google Shape;336;p9">
            <a:extLst>
              <a:ext uri="{FF2B5EF4-FFF2-40B4-BE49-F238E27FC236}">
                <a16:creationId xmlns:a16="http://schemas.microsoft.com/office/drawing/2014/main" id="{B12587C7-F877-7E19-EE8F-10782DEA45AE}"/>
              </a:ext>
            </a:extLst>
          </p:cNvPr>
          <p:cNvSpPr txBox="1"/>
          <p:nvPr/>
        </p:nvSpPr>
        <p:spPr>
          <a:xfrm>
            <a:off x="14630" y="6937094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" name="Google Shape;102;p1">
            <a:extLst>
              <a:ext uri="{FF2B5EF4-FFF2-40B4-BE49-F238E27FC236}">
                <a16:creationId xmlns:a16="http://schemas.microsoft.com/office/drawing/2014/main" id="{4E0DF1C5-48A6-4747-F117-50098C229305}"/>
              </a:ext>
            </a:extLst>
          </p:cNvPr>
          <p:cNvSpPr txBox="1"/>
          <p:nvPr/>
        </p:nvSpPr>
        <p:spPr>
          <a:xfrm>
            <a:off x="255198" y="45030"/>
            <a:ext cx="6394235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upplementary Figure S3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. </a:t>
            </a: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ATAC-seq of HCT116 oxaliplatin-resistant models</a:t>
            </a:r>
            <a:endParaRPr lang="en-US" sz="12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705744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30C525C-CD5F-2745-ABBA-A693C06A4AF9}"/>
              </a:ext>
            </a:extLst>
          </p:cNvPr>
          <p:cNvSpPr txBox="1"/>
          <p:nvPr/>
        </p:nvSpPr>
        <p:spPr>
          <a:xfrm>
            <a:off x="342900" y="293914"/>
            <a:ext cx="633548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ATAC-seq of HCT116 oxaliplatin-resistant model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C-seq signal tracks in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PINE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 Red line indicates region of SMAD-binding motif within an area of differential peaks (top). Identification of SMAD-binding motif in the 5’UTR region (bottom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put from FIMO tool motif enrichment analyses under MEME suite 5.5.7 showing significant enrichment of SMAD-binding motif (MA0513.1)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PINE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 of interest (+/-1kb from start of 5’UTR: chr7:101,126,104-101,128,104).</a:t>
            </a:r>
          </a:p>
        </p:txBody>
      </p:sp>
    </p:spTree>
    <p:extLst>
      <p:ext uri="{BB962C8B-B14F-4D97-AF65-F5344CB8AC3E}">
        <p14:creationId xmlns:p14="http://schemas.microsoft.com/office/powerpoint/2010/main" val="3914744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26</TotalTime>
  <Words>118</Words>
  <Application>Microsoft Macintosh PowerPoint</Application>
  <PresentationFormat>A4 Paper (210x297 mm)</PresentationFormat>
  <Paragraphs>29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W</dc:creator>
  <cp:lastModifiedBy>Wong, Stephen Q.</cp:lastModifiedBy>
  <cp:revision>1044</cp:revision>
  <dcterms:created xsi:type="dcterms:W3CDTF">2020-08-02T08:32:23Z</dcterms:created>
  <dcterms:modified xsi:type="dcterms:W3CDTF">2025-06-24T17:46:09Z</dcterms:modified>
</cp:coreProperties>
</file>